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578725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3617" autoAdjust="0"/>
  </p:normalViewPr>
  <p:slideViewPr>
    <p:cSldViewPr snapToGrid="0">
      <p:cViewPr>
        <p:scale>
          <a:sx n="150" d="100"/>
          <a:sy n="150" d="100"/>
        </p:scale>
        <p:origin x="540" y="-2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8405" y="1995312"/>
            <a:ext cx="6441916" cy="4244622"/>
          </a:xfrm>
        </p:spPr>
        <p:txBody>
          <a:bodyPr anchor="b"/>
          <a:lstStyle>
            <a:lvl1pPr algn="ctr">
              <a:defRPr sz="4973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7341" y="6403623"/>
            <a:ext cx="5684044" cy="2943577"/>
          </a:xfrm>
        </p:spPr>
        <p:txBody>
          <a:bodyPr/>
          <a:lstStyle>
            <a:lvl1pPr marL="0" indent="0" algn="ctr">
              <a:buNone/>
              <a:defRPr sz="1989"/>
            </a:lvl1pPr>
            <a:lvl2pPr marL="378927" indent="0" algn="ctr">
              <a:buNone/>
              <a:defRPr sz="1658"/>
            </a:lvl2pPr>
            <a:lvl3pPr marL="757855" indent="0" algn="ctr">
              <a:buNone/>
              <a:defRPr sz="1492"/>
            </a:lvl3pPr>
            <a:lvl4pPr marL="1136782" indent="0" algn="ctr">
              <a:buNone/>
              <a:defRPr sz="1326"/>
            </a:lvl4pPr>
            <a:lvl5pPr marL="1515709" indent="0" algn="ctr">
              <a:buNone/>
              <a:defRPr sz="1326"/>
            </a:lvl5pPr>
            <a:lvl6pPr marL="1894637" indent="0" algn="ctr">
              <a:buNone/>
              <a:defRPr sz="1326"/>
            </a:lvl6pPr>
            <a:lvl7pPr marL="2273564" indent="0" algn="ctr">
              <a:buNone/>
              <a:defRPr sz="1326"/>
            </a:lvl7pPr>
            <a:lvl8pPr marL="2652492" indent="0" algn="ctr">
              <a:buNone/>
              <a:defRPr sz="1326"/>
            </a:lvl8pPr>
            <a:lvl9pPr marL="3031419" indent="0" algn="ctr">
              <a:buNone/>
              <a:defRPr sz="1326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1811A-593D-40C1-833D-09398B1E7BB5}" type="datetimeFigureOut">
              <a:rPr lang="es-ES" smtClean="0"/>
              <a:t>11/06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DAD71-2D14-432F-A2B2-0DA212597D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5481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1811A-593D-40C1-833D-09398B1E7BB5}" type="datetimeFigureOut">
              <a:rPr lang="es-ES" smtClean="0"/>
              <a:t>11/06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DAD71-2D14-432F-A2B2-0DA212597D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30540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23525" y="649111"/>
            <a:ext cx="1634163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21038" y="649111"/>
            <a:ext cx="480775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1811A-593D-40C1-833D-09398B1E7BB5}" type="datetimeFigureOut">
              <a:rPr lang="es-ES" smtClean="0"/>
              <a:t>11/06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DAD71-2D14-432F-A2B2-0DA212597D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1154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1811A-593D-40C1-833D-09398B1E7BB5}" type="datetimeFigureOut">
              <a:rPr lang="es-ES" smtClean="0"/>
              <a:t>11/06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DAD71-2D14-432F-A2B2-0DA212597D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5464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7091" y="3039537"/>
            <a:ext cx="6536650" cy="5071532"/>
          </a:xfrm>
        </p:spPr>
        <p:txBody>
          <a:bodyPr anchor="b"/>
          <a:lstStyle>
            <a:lvl1pPr>
              <a:defRPr sz="4973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7091" y="8159048"/>
            <a:ext cx="6536650" cy="2666999"/>
          </a:xfrm>
        </p:spPr>
        <p:txBody>
          <a:bodyPr/>
          <a:lstStyle>
            <a:lvl1pPr marL="0" indent="0">
              <a:buNone/>
              <a:defRPr sz="1989">
                <a:solidFill>
                  <a:schemeClr val="tx1"/>
                </a:solidFill>
              </a:defRPr>
            </a:lvl1pPr>
            <a:lvl2pPr marL="378927" indent="0">
              <a:buNone/>
              <a:defRPr sz="1658">
                <a:solidFill>
                  <a:schemeClr val="tx1">
                    <a:tint val="75000"/>
                  </a:schemeClr>
                </a:solidFill>
              </a:defRPr>
            </a:lvl2pPr>
            <a:lvl3pPr marL="757855" indent="0">
              <a:buNone/>
              <a:defRPr sz="1492">
                <a:solidFill>
                  <a:schemeClr val="tx1">
                    <a:tint val="75000"/>
                  </a:schemeClr>
                </a:solidFill>
              </a:defRPr>
            </a:lvl3pPr>
            <a:lvl4pPr marL="1136782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4pPr>
            <a:lvl5pPr marL="1515709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5pPr>
            <a:lvl6pPr marL="1894637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6pPr>
            <a:lvl7pPr marL="2273564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7pPr>
            <a:lvl8pPr marL="2652492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8pPr>
            <a:lvl9pPr marL="3031419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1811A-593D-40C1-833D-09398B1E7BB5}" type="datetimeFigureOut">
              <a:rPr lang="es-ES" smtClean="0"/>
              <a:t>11/06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DAD71-2D14-432F-A2B2-0DA212597D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2165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21037" y="3245556"/>
            <a:ext cx="3220958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36730" y="3245556"/>
            <a:ext cx="3220958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1811A-593D-40C1-833D-09398B1E7BB5}" type="datetimeFigureOut">
              <a:rPr lang="es-ES" smtClean="0"/>
              <a:t>11/06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DAD71-2D14-432F-A2B2-0DA212597D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731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025" y="649114"/>
            <a:ext cx="6536650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2026" y="2988734"/>
            <a:ext cx="3206155" cy="1464732"/>
          </a:xfrm>
        </p:spPr>
        <p:txBody>
          <a:bodyPr anchor="b"/>
          <a:lstStyle>
            <a:lvl1pPr marL="0" indent="0">
              <a:buNone/>
              <a:defRPr sz="1989" b="1"/>
            </a:lvl1pPr>
            <a:lvl2pPr marL="378927" indent="0">
              <a:buNone/>
              <a:defRPr sz="1658" b="1"/>
            </a:lvl2pPr>
            <a:lvl3pPr marL="757855" indent="0">
              <a:buNone/>
              <a:defRPr sz="1492" b="1"/>
            </a:lvl3pPr>
            <a:lvl4pPr marL="1136782" indent="0">
              <a:buNone/>
              <a:defRPr sz="1326" b="1"/>
            </a:lvl4pPr>
            <a:lvl5pPr marL="1515709" indent="0">
              <a:buNone/>
              <a:defRPr sz="1326" b="1"/>
            </a:lvl5pPr>
            <a:lvl6pPr marL="1894637" indent="0">
              <a:buNone/>
              <a:defRPr sz="1326" b="1"/>
            </a:lvl6pPr>
            <a:lvl7pPr marL="2273564" indent="0">
              <a:buNone/>
              <a:defRPr sz="1326" b="1"/>
            </a:lvl7pPr>
            <a:lvl8pPr marL="2652492" indent="0">
              <a:buNone/>
              <a:defRPr sz="1326" b="1"/>
            </a:lvl8pPr>
            <a:lvl9pPr marL="3031419" indent="0">
              <a:buNone/>
              <a:defRPr sz="1326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2026" y="4453467"/>
            <a:ext cx="32061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36730" y="2988734"/>
            <a:ext cx="3221945" cy="1464732"/>
          </a:xfrm>
        </p:spPr>
        <p:txBody>
          <a:bodyPr anchor="b"/>
          <a:lstStyle>
            <a:lvl1pPr marL="0" indent="0">
              <a:buNone/>
              <a:defRPr sz="1989" b="1"/>
            </a:lvl1pPr>
            <a:lvl2pPr marL="378927" indent="0">
              <a:buNone/>
              <a:defRPr sz="1658" b="1"/>
            </a:lvl2pPr>
            <a:lvl3pPr marL="757855" indent="0">
              <a:buNone/>
              <a:defRPr sz="1492" b="1"/>
            </a:lvl3pPr>
            <a:lvl4pPr marL="1136782" indent="0">
              <a:buNone/>
              <a:defRPr sz="1326" b="1"/>
            </a:lvl4pPr>
            <a:lvl5pPr marL="1515709" indent="0">
              <a:buNone/>
              <a:defRPr sz="1326" b="1"/>
            </a:lvl5pPr>
            <a:lvl6pPr marL="1894637" indent="0">
              <a:buNone/>
              <a:defRPr sz="1326" b="1"/>
            </a:lvl6pPr>
            <a:lvl7pPr marL="2273564" indent="0">
              <a:buNone/>
              <a:defRPr sz="1326" b="1"/>
            </a:lvl7pPr>
            <a:lvl8pPr marL="2652492" indent="0">
              <a:buNone/>
              <a:defRPr sz="1326" b="1"/>
            </a:lvl8pPr>
            <a:lvl9pPr marL="3031419" indent="0">
              <a:buNone/>
              <a:defRPr sz="1326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36730" y="4453467"/>
            <a:ext cx="322194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1811A-593D-40C1-833D-09398B1E7BB5}" type="datetimeFigureOut">
              <a:rPr lang="es-ES" smtClean="0"/>
              <a:t>11/06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DAD71-2D14-432F-A2B2-0DA212597D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95838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1811A-593D-40C1-833D-09398B1E7BB5}" type="datetimeFigureOut">
              <a:rPr lang="es-ES" smtClean="0"/>
              <a:t>11/06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DAD71-2D14-432F-A2B2-0DA212597D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1499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1811A-593D-40C1-833D-09398B1E7BB5}" type="datetimeFigureOut">
              <a:rPr lang="es-ES" smtClean="0"/>
              <a:t>11/06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DAD71-2D14-432F-A2B2-0DA212597D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5538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025" y="812800"/>
            <a:ext cx="2444336" cy="2844800"/>
          </a:xfrm>
        </p:spPr>
        <p:txBody>
          <a:bodyPr anchor="b"/>
          <a:lstStyle>
            <a:lvl1pPr>
              <a:defRPr sz="265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21945" y="1755425"/>
            <a:ext cx="3836730" cy="8664222"/>
          </a:xfrm>
        </p:spPr>
        <p:txBody>
          <a:bodyPr/>
          <a:lstStyle>
            <a:lvl1pPr>
              <a:defRPr sz="2652"/>
            </a:lvl1pPr>
            <a:lvl2pPr>
              <a:defRPr sz="2321"/>
            </a:lvl2pPr>
            <a:lvl3pPr>
              <a:defRPr sz="1989"/>
            </a:lvl3pPr>
            <a:lvl4pPr>
              <a:defRPr sz="1658"/>
            </a:lvl4pPr>
            <a:lvl5pPr>
              <a:defRPr sz="1658"/>
            </a:lvl5pPr>
            <a:lvl6pPr>
              <a:defRPr sz="1658"/>
            </a:lvl6pPr>
            <a:lvl7pPr>
              <a:defRPr sz="1658"/>
            </a:lvl7pPr>
            <a:lvl8pPr>
              <a:defRPr sz="1658"/>
            </a:lvl8pPr>
            <a:lvl9pPr>
              <a:defRPr sz="1658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025" y="3657600"/>
            <a:ext cx="2444336" cy="6776156"/>
          </a:xfrm>
        </p:spPr>
        <p:txBody>
          <a:bodyPr/>
          <a:lstStyle>
            <a:lvl1pPr marL="0" indent="0">
              <a:buNone/>
              <a:defRPr sz="1326"/>
            </a:lvl1pPr>
            <a:lvl2pPr marL="378927" indent="0">
              <a:buNone/>
              <a:defRPr sz="1160"/>
            </a:lvl2pPr>
            <a:lvl3pPr marL="757855" indent="0">
              <a:buNone/>
              <a:defRPr sz="995"/>
            </a:lvl3pPr>
            <a:lvl4pPr marL="1136782" indent="0">
              <a:buNone/>
              <a:defRPr sz="829"/>
            </a:lvl4pPr>
            <a:lvl5pPr marL="1515709" indent="0">
              <a:buNone/>
              <a:defRPr sz="829"/>
            </a:lvl5pPr>
            <a:lvl6pPr marL="1894637" indent="0">
              <a:buNone/>
              <a:defRPr sz="829"/>
            </a:lvl6pPr>
            <a:lvl7pPr marL="2273564" indent="0">
              <a:buNone/>
              <a:defRPr sz="829"/>
            </a:lvl7pPr>
            <a:lvl8pPr marL="2652492" indent="0">
              <a:buNone/>
              <a:defRPr sz="829"/>
            </a:lvl8pPr>
            <a:lvl9pPr marL="3031419" indent="0">
              <a:buNone/>
              <a:defRPr sz="82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1811A-593D-40C1-833D-09398B1E7BB5}" type="datetimeFigureOut">
              <a:rPr lang="es-ES" smtClean="0"/>
              <a:t>11/06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DAD71-2D14-432F-A2B2-0DA212597D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688930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025" y="812800"/>
            <a:ext cx="2444336" cy="2844800"/>
          </a:xfrm>
        </p:spPr>
        <p:txBody>
          <a:bodyPr anchor="b"/>
          <a:lstStyle>
            <a:lvl1pPr>
              <a:defRPr sz="265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21945" y="1755425"/>
            <a:ext cx="3836730" cy="8664222"/>
          </a:xfrm>
        </p:spPr>
        <p:txBody>
          <a:bodyPr anchor="t"/>
          <a:lstStyle>
            <a:lvl1pPr marL="0" indent="0">
              <a:buNone/>
              <a:defRPr sz="2652"/>
            </a:lvl1pPr>
            <a:lvl2pPr marL="378927" indent="0">
              <a:buNone/>
              <a:defRPr sz="2321"/>
            </a:lvl2pPr>
            <a:lvl3pPr marL="757855" indent="0">
              <a:buNone/>
              <a:defRPr sz="1989"/>
            </a:lvl3pPr>
            <a:lvl4pPr marL="1136782" indent="0">
              <a:buNone/>
              <a:defRPr sz="1658"/>
            </a:lvl4pPr>
            <a:lvl5pPr marL="1515709" indent="0">
              <a:buNone/>
              <a:defRPr sz="1658"/>
            </a:lvl5pPr>
            <a:lvl6pPr marL="1894637" indent="0">
              <a:buNone/>
              <a:defRPr sz="1658"/>
            </a:lvl6pPr>
            <a:lvl7pPr marL="2273564" indent="0">
              <a:buNone/>
              <a:defRPr sz="1658"/>
            </a:lvl7pPr>
            <a:lvl8pPr marL="2652492" indent="0">
              <a:buNone/>
              <a:defRPr sz="1658"/>
            </a:lvl8pPr>
            <a:lvl9pPr marL="3031419" indent="0">
              <a:buNone/>
              <a:defRPr sz="1658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025" y="3657600"/>
            <a:ext cx="2444336" cy="6776156"/>
          </a:xfrm>
        </p:spPr>
        <p:txBody>
          <a:bodyPr/>
          <a:lstStyle>
            <a:lvl1pPr marL="0" indent="0">
              <a:buNone/>
              <a:defRPr sz="1326"/>
            </a:lvl1pPr>
            <a:lvl2pPr marL="378927" indent="0">
              <a:buNone/>
              <a:defRPr sz="1160"/>
            </a:lvl2pPr>
            <a:lvl3pPr marL="757855" indent="0">
              <a:buNone/>
              <a:defRPr sz="995"/>
            </a:lvl3pPr>
            <a:lvl4pPr marL="1136782" indent="0">
              <a:buNone/>
              <a:defRPr sz="829"/>
            </a:lvl4pPr>
            <a:lvl5pPr marL="1515709" indent="0">
              <a:buNone/>
              <a:defRPr sz="829"/>
            </a:lvl5pPr>
            <a:lvl6pPr marL="1894637" indent="0">
              <a:buNone/>
              <a:defRPr sz="829"/>
            </a:lvl6pPr>
            <a:lvl7pPr marL="2273564" indent="0">
              <a:buNone/>
              <a:defRPr sz="829"/>
            </a:lvl7pPr>
            <a:lvl8pPr marL="2652492" indent="0">
              <a:buNone/>
              <a:defRPr sz="829"/>
            </a:lvl8pPr>
            <a:lvl9pPr marL="3031419" indent="0">
              <a:buNone/>
              <a:defRPr sz="82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1811A-593D-40C1-833D-09398B1E7BB5}" type="datetimeFigureOut">
              <a:rPr lang="es-ES" smtClean="0"/>
              <a:t>11/06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DAD71-2D14-432F-A2B2-0DA212597D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84716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21038" y="649114"/>
            <a:ext cx="653665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1038" y="3245556"/>
            <a:ext cx="653665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21037" y="11300181"/>
            <a:ext cx="1705213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31811A-593D-40C1-833D-09398B1E7BB5}" type="datetimeFigureOut">
              <a:rPr lang="es-ES" smtClean="0"/>
              <a:t>11/06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10453" y="11300181"/>
            <a:ext cx="255782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52475" y="11300181"/>
            <a:ext cx="1705213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DDAD71-2D14-432F-A2B2-0DA212597D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87645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7855" rtl="0" eaLnBrk="1" latinLnBrk="0" hangingPunct="1">
        <a:lnSpc>
          <a:spcPct val="90000"/>
        </a:lnSpc>
        <a:spcBef>
          <a:spcPct val="0"/>
        </a:spcBef>
        <a:buNone/>
        <a:defRPr sz="364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464" indent="-189464" algn="l" defTabSz="757855" rtl="0" eaLnBrk="1" latinLnBrk="0" hangingPunct="1">
        <a:lnSpc>
          <a:spcPct val="90000"/>
        </a:lnSpc>
        <a:spcBef>
          <a:spcPts val="829"/>
        </a:spcBef>
        <a:buFont typeface="Arial" panose="020B0604020202020204" pitchFamily="34" charset="0"/>
        <a:buChar char="•"/>
        <a:defRPr sz="2321" kern="1200">
          <a:solidFill>
            <a:schemeClr val="tx1"/>
          </a:solidFill>
          <a:latin typeface="+mn-lt"/>
          <a:ea typeface="+mn-ea"/>
          <a:cs typeface="+mn-cs"/>
        </a:defRPr>
      </a:lvl1pPr>
      <a:lvl2pPr marL="568391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989" kern="1200">
          <a:solidFill>
            <a:schemeClr val="tx1"/>
          </a:solidFill>
          <a:latin typeface="+mn-lt"/>
          <a:ea typeface="+mn-ea"/>
          <a:cs typeface="+mn-cs"/>
        </a:defRPr>
      </a:lvl2pPr>
      <a:lvl3pPr marL="947318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658" kern="1200">
          <a:solidFill>
            <a:schemeClr val="tx1"/>
          </a:solidFill>
          <a:latin typeface="+mn-lt"/>
          <a:ea typeface="+mn-ea"/>
          <a:cs typeface="+mn-cs"/>
        </a:defRPr>
      </a:lvl3pPr>
      <a:lvl4pPr marL="1326246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4pPr>
      <a:lvl5pPr marL="1705173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5pPr>
      <a:lvl6pPr marL="2084100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6pPr>
      <a:lvl7pPr marL="2463028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7pPr>
      <a:lvl8pPr marL="2841955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8pPr>
      <a:lvl9pPr marL="3220883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1pPr>
      <a:lvl2pPr marL="378927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2pPr>
      <a:lvl3pPr marL="757855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3pPr>
      <a:lvl4pPr marL="1136782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4pPr>
      <a:lvl5pPr marL="1515709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5pPr>
      <a:lvl6pPr marL="1894637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6pPr>
      <a:lvl7pPr marL="2273564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7pPr>
      <a:lvl8pPr marL="2652492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8pPr>
      <a:lvl9pPr marL="3031419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CuadroTexto 120">
            <a:extLst>
              <a:ext uri="{FF2B5EF4-FFF2-40B4-BE49-F238E27FC236}">
                <a16:creationId xmlns:a16="http://schemas.microsoft.com/office/drawing/2014/main" id="{83789994-56E4-3A5F-CE5B-2967BDF7FA4C}"/>
              </a:ext>
            </a:extLst>
          </p:cNvPr>
          <p:cNvSpPr txBox="1"/>
          <p:nvPr/>
        </p:nvSpPr>
        <p:spPr>
          <a:xfrm>
            <a:off x="2431627" y="4773025"/>
            <a:ext cx="2823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</a:p>
        </p:txBody>
      </p:sp>
      <p:pic>
        <p:nvPicPr>
          <p:cNvPr id="119" name="Imagen 118" descr="Imagen que contiene artículos, refrigerador, morado, tabla&#10;&#10;Descripción generada automáticamente">
            <a:extLst>
              <a:ext uri="{FF2B5EF4-FFF2-40B4-BE49-F238E27FC236}">
                <a16:creationId xmlns:a16="http://schemas.microsoft.com/office/drawing/2014/main" id="{E55DB019-6838-381B-D82F-2F15D7BBD4C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2000" contrast="1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566" t="25997" r="50798" b="57585"/>
          <a:stretch/>
        </p:blipFill>
        <p:spPr>
          <a:xfrm rot="5400000">
            <a:off x="379246" y="2289187"/>
            <a:ext cx="2271034" cy="136222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47" name="Imagen 146" descr="Imagen que contiene cama&#10;&#10;Descripción generada automáticamente">
            <a:extLst>
              <a:ext uri="{FF2B5EF4-FFF2-40B4-BE49-F238E27FC236}">
                <a16:creationId xmlns:a16="http://schemas.microsoft.com/office/drawing/2014/main" id="{603B24E7-D0FA-5476-4A67-D06AF6FB882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174" t="4163" r="76523" b="62059"/>
          <a:stretch/>
        </p:blipFill>
        <p:spPr>
          <a:xfrm>
            <a:off x="4301772" y="1832095"/>
            <a:ext cx="1416507" cy="227372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49" name="CuadroTexto 148">
            <a:extLst>
              <a:ext uri="{FF2B5EF4-FFF2-40B4-BE49-F238E27FC236}">
                <a16:creationId xmlns:a16="http://schemas.microsoft.com/office/drawing/2014/main" id="{46CA622C-C317-771B-E30D-B3D08961B688}"/>
              </a:ext>
            </a:extLst>
          </p:cNvPr>
          <p:cNvSpPr txBox="1"/>
          <p:nvPr/>
        </p:nvSpPr>
        <p:spPr>
          <a:xfrm rot="16200000">
            <a:off x="4155153" y="1364989"/>
            <a:ext cx="742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CuadroTexto 149">
            <a:extLst>
              <a:ext uri="{FF2B5EF4-FFF2-40B4-BE49-F238E27FC236}">
                <a16:creationId xmlns:a16="http://schemas.microsoft.com/office/drawing/2014/main" id="{B012443D-D5EE-77ED-2B37-E93321B20E40}"/>
              </a:ext>
            </a:extLst>
          </p:cNvPr>
          <p:cNvSpPr txBox="1"/>
          <p:nvPr/>
        </p:nvSpPr>
        <p:spPr>
          <a:xfrm rot="16200000">
            <a:off x="4479687" y="1364989"/>
            <a:ext cx="742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SPRYD7</a:t>
            </a:r>
          </a:p>
        </p:txBody>
      </p:sp>
      <p:sp>
        <p:nvSpPr>
          <p:cNvPr id="151" name="CuadroTexto 150">
            <a:extLst>
              <a:ext uri="{FF2B5EF4-FFF2-40B4-BE49-F238E27FC236}">
                <a16:creationId xmlns:a16="http://schemas.microsoft.com/office/drawing/2014/main" id="{152671C7-2E47-252F-D508-D7EDE5D3F464}"/>
              </a:ext>
            </a:extLst>
          </p:cNvPr>
          <p:cNvSpPr txBox="1"/>
          <p:nvPr/>
        </p:nvSpPr>
        <p:spPr>
          <a:xfrm rot="16200000">
            <a:off x="4802232" y="1364989"/>
            <a:ext cx="742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CuadroTexto 151">
            <a:extLst>
              <a:ext uri="{FF2B5EF4-FFF2-40B4-BE49-F238E27FC236}">
                <a16:creationId xmlns:a16="http://schemas.microsoft.com/office/drawing/2014/main" id="{AF48C02C-95B0-9CED-C873-DF2CF1A297E0}"/>
              </a:ext>
            </a:extLst>
          </p:cNvPr>
          <p:cNvSpPr txBox="1"/>
          <p:nvPr/>
        </p:nvSpPr>
        <p:spPr>
          <a:xfrm rot="16200000">
            <a:off x="5166770" y="1364989"/>
            <a:ext cx="742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SPRYD7</a:t>
            </a:r>
          </a:p>
        </p:txBody>
      </p:sp>
      <p:sp>
        <p:nvSpPr>
          <p:cNvPr id="153" name="CuadroTexto 152">
            <a:extLst>
              <a:ext uri="{FF2B5EF4-FFF2-40B4-BE49-F238E27FC236}">
                <a16:creationId xmlns:a16="http://schemas.microsoft.com/office/drawing/2014/main" id="{CDC7021B-36DA-7D53-24DD-A4B0967B88A6}"/>
              </a:ext>
            </a:extLst>
          </p:cNvPr>
          <p:cNvSpPr txBox="1"/>
          <p:nvPr/>
        </p:nvSpPr>
        <p:spPr>
          <a:xfrm rot="16200000">
            <a:off x="5701258" y="1364989"/>
            <a:ext cx="742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CuadroTexto 153">
            <a:extLst>
              <a:ext uri="{FF2B5EF4-FFF2-40B4-BE49-F238E27FC236}">
                <a16:creationId xmlns:a16="http://schemas.microsoft.com/office/drawing/2014/main" id="{1D39C9EF-D9DC-0C57-D1D9-1E5CAC783A02}"/>
              </a:ext>
            </a:extLst>
          </p:cNvPr>
          <p:cNvSpPr txBox="1"/>
          <p:nvPr/>
        </p:nvSpPr>
        <p:spPr>
          <a:xfrm rot="16200000">
            <a:off x="6026847" y="1364989"/>
            <a:ext cx="742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SPRYD7</a:t>
            </a:r>
          </a:p>
        </p:txBody>
      </p:sp>
      <p:sp>
        <p:nvSpPr>
          <p:cNvPr id="155" name="CuadroTexto 154">
            <a:extLst>
              <a:ext uri="{FF2B5EF4-FFF2-40B4-BE49-F238E27FC236}">
                <a16:creationId xmlns:a16="http://schemas.microsoft.com/office/drawing/2014/main" id="{ED27EA23-9AC0-853F-4482-4149AD194ED9}"/>
              </a:ext>
            </a:extLst>
          </p:cNvPr>
          <p:cNvSpPr txBox="1"/>
          <p:nvPr/>
        </p:nvSpPr>
        <p:spPr>
          <a:xfrm rot="16200000">
            <a:off x="6336693" y="1364989"/>
            <a:ext cx="742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CuadroTexto 155">
            <a:extLst>
              <a:ext uri="{FF2B5EF4-FFF2-40B4-BE49-F238E27FC236}">
                <a16:creationId xmlns:a16="http://schemas.microsoft.com/office/drawing/2014/main" id="{7ED9E155-6C1E-DE1D-17B4-920BDC176079}"/>
              </a:ext>
            </a:extLst>
          </p:cNvPr>
          <p:cNvSpPr txBox="1"/>
          <p:nvPr/>
        </p:nvSpPr>
        <p:spPr>
          <a:xfrm rot="16200000">
            <a:off x="6665458" y="1364989"/>
            <a:ext cx="742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SPRYD7</a:t>
            </a:r>
          </a:p>
        </p:txBody>
      </p:sp>
      <p:sp>
        <p:nvSpPr>
          <p:cNvPr id="157" name="CuadroTexto 156">
            <a:extLst>
              <a:ext uri="{FF2B5EF4-FFF2-40B4-BE49-F238E27FC236}">
                <a16:creationId xmlns:a16="http://schemas.microsoft.com/office/drawing/2014/main" id="{68881CCF-ED29-F72C-C6A3-D55C089BC193}"/>
              </a:ext>
            </a:extLst>
          </p:cNvPr>
          <p:cNvSpPr txBox="1"/>
          <p:nvPr/>
        </p:nvSpPr>
        <p:spPr>
          <a:xfrm>
            <a:off x="3872233" y="2787929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58" name="CuadroTexto 157">
            <a:extLst>
              <a:ext uri="{FF2B5EF4-FFF2-40B4-BE49-F238E27FC236}">
                <a16:creationId xmlns:a16="http://schemas.microsoft.com/office/drawing/2014/main" id="{7A64A35C-ACD8-164F-F221-B96A66872686}"/>
              </a:ext>
            </a:extLst>
          </p:cNvPr>
          <p:cNvSpPr txBox="1"/>
          <p:nvPr/>
        </p:nvSpPr>
        <p:spPr>
          <a:xfrm>
            <a:off x="3872233" y="3615749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59" name="CuadroTexto 158">
            <a:extLst>
              <a:ext uri="{FF2B5EF4-FFF2-40B4-BE49-F238E27FC236}">
                <a16:creationId xmlns:a16="http://schemas.microsoft.com/office/drawing/2014/main" id="{46DC8ED8-3916-60A3-7612-981C487FD477}"/>
              </a:ext>
            </a:extLst>
          </p:cNvPr>
          <p:cNvSpPr txBox="1"/>
          <p:nvPr/>
        </p:nvSpPr>
        <p:spPr>
          <a:xfrm>
            <a:off x="3872233" y="2450513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160" name="CuadroTexto 159">
            <a:extLst>
              <a:ext uri="{FF2B5EF4-FFF2-40B4-BE49-F238E27FC236}">
                <a16:creationId xmlns:a16="http://schemas.microsoft.com/office/drawing/2014/main" id="{972243D8-E789-1074-2F5C-AC2743FB1D57}"/>
              </a:ext>
            </a:extLst>
          </p:cNvPr>
          <p:cNvSpPr txBox="1"/>
          <p:nvPr/>
        </p:nvSpPr>
        <p:spPr>
          <a:xfrm>
            <a:off x="3872233" y="2258967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161" name="CuadroTexto 160">
            <a:extLst>
              <a:ext uri="{FF2B5EF4-FFF2-40B4-BE49-F238E27FC236}">
                <a16:creationId xmlns:a16="http://schemas.microsoft.com/office/drawing/2014/main" id="{C2E9F67E-858F-2D6D-B86E-257ECDD5A3AB}"/>
              </a:ext>
            </a:extLst>
          </p:cNvPr>
          <p:cNvSpPr txBox="1"/>
          <p:nvPr/>
        </p:nvSpPr>
        <p:spPr>
          <a:xfrm>
            <a:off x="3872233" y="2136877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62" name="CuadroTexto 161">
            <a:extLst>
              <a:ext uri="{FF2B5EF4-FFF2-40B4-BE49-F238E27FC236}">
                <a16:creationId xmlns:a16="http://schemas.microsoft.com/office/drawing/2014/main" id="{466F16F2-5DFC-12A4-280D-20252B9773B3}"/>
              </a:ext>
            </a:extLst>
          </p:cNvPr>
          <p:cNvSpPr txBox="1"/>
          <p:nvPr/>
        </p:nvSpPr>
        <p:spPr>
          <a:xfrm>
            <a:off x="3872233" y="2009484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163" name="CuadroTexto 162">
            <a:extLst>
              <a:ext uri="{FF2B5EF4-FFF2-40B4-BE49-F238E27FC236}">
                <a16:creationId xmlns:a16="http://schemas.microsoft.com/office/drawing/2014/main" id="{DCE663F2-62A2-2263-102A-B5C659A8FCBC}"/>
              </a:ext>
            </a:extLst>
          </p:cNvPr>
          <p:cNvSpPr txBox="1"/>
          <p:nvPr/>
        </p:nvSpPr>
        <p:spPr>
          <a:xfrm>
            <a:off x="3872233" y="1873058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64" name="CuadroTexto 163">
            <a:extLst>
              <a:ext uri="{FF2B5EF4-FFF2-40B4-BE49-F238E27FC236}">
                <a16:creationId xmlns:a16="http://schemas.microsoft.com/office/drawing/2014/main" id="{DF27D6D9-20DC-CD0F-FA3B-085C7942B754}"/>
              </a:ext>
            </a:extLst>
          </p:cNvPr>
          <p:cNvSpPr txBox="1"/>
          <p:nvPr/>
        </p:nvSpPr>
        <p:spPr>
          <a:xfrm>
            <a:off x="3872233" y="1597886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5" name="Conector recto 164">
            <a:extLst>
              <a:ext uri="{FF2B5EF4-FFF2-40B4-BE49-F238E27FC236}">
                <a16:creationId xmlns:a16="http://schemas.microsoft.com/office/drawing/2014/main" id="{D6F6D9F8-CD0B-43B4-9D74-2673098B2CF0}"/>
              </a:ext>
            </a:extLst>
          </p:cNvPr>
          <p:cNvCxnSpPr>
            <a:cxnSpLocks/>
          </p:cNvCxnSpPr>
          <p:nvPr/>
        </p:nvCxnSpPr>
        <p:spPr>
          <a:xfrm flipV="1">
            <a:off x="5901982" y="1146081"/>
            <a:ext cx="5606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CuadroTexto 165">
            <a:extLst>
              <a:ext uri="{FF2B5EF4-FFF2-40B4-BE49-F238E27FC236}">
                <a16:creationId xmlns:a16="http://schemas.microsoft.com/office/drawing/2014/main" id="{2A8F1866-08AC-BBC5-FEB3-004FAF72D3EC}"/>
              </a:ext>
            </a:extLst>
          </p:cNvPr>
          <p:cNvSpPr txBox="1"/>
          <p:nvPr/>
        </p:nvSpPr>
        <p:spPr>
          <a:xfrm>
            <a:off x="5848577" y="908057"/>
            <a:ext cx="6674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SW480</a:t>
            </a:r>
          </a:p>
        </p:txBody>
      </p:sp>
      <p:sp>
        <p:nvSpPr>
          <p:cNvPr id="167" name="CuadroTexto 166">
            <a:extLst>
              <a:ext uri="{FF2B5EF4-FFF2-40B4-BE49-F238E27FC236}">
                <a16:creationId xmlns:a16="http://schemas.microsoft.com/office/drawing/2014/main" id="{56216893-08C4-20C6-76AE-E9D31789E84A}"/>
              </a:ext>
            </a:extLst>
          </p:cNvPr>
          <p:cNvSpPr txBox="1"/>
          <p:nvPr/>
        </p:nvSpPr>
        <p:spPr>
          <a:xfrm>
            <a:off x="3872233" y="3039055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168" name="Conector recto 167">
            <a:extLst>
              <a:ext uri="{FF2B5EF4-FFF2-40B4-BE49-F238E27FC236}">
                <a16:creationId xmlns:a16="http://schemas.microsoft.com/office/drawing/2014/main" id="{CD692C60-F525-ECB8-4F56-49A3A96B7337}"/>
              </a:ext>
            </a:extLst>
          </p:cNvPr>
          <p:cNvCxnSpPr>
            <a:cxnSpLocks/>
          </p:cNvCxnSpPr>
          <p:nvPr/>
        </p:nvCxnSpPr>
        <p:spPr>
          <a:xfrm flipV="1">
            <a:off x="6587591" y="1146081"/>
            <a:ext cx="5606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CuadroTexto 168">
            <a:extLst>
              <a:ext uri="{FF2B5EF4-FFF2-40B4-BE49-F238E27FC236}">
                <a16:creationId xmlns:a16="http://schemas.microsoft.com/office/drawing/2014/main" id="{CDE8DBD6-E3F4-C384-763A-FF9778380DEB}"/>
              </a:ext>
            </a:extLst>
          </p:cNvPr>
          <p:cNvSpPr txBox="1"/>
          <p:nvPr/>
        </p:nvSpPr>
        <p:spPr>
          <a:xfrm>
            <a:off x="6534186" y="908057"/>
            <a:ext cx="6674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SW620</a:t>
            </a:r>
          </a:p>
        </p:txBody>
      </p:sp>
      <p:cxnSp>
        <p:nvCxnSpPr>
          <p:cNvPr id="170" name="Conector recto 169">
            <a:extLst>
              <a:ext uri="{FF2B5EF4-FFF2-40B4-BE49-F238E27FC236}">
                <a16:creationId xmlns:a16="http://schemas.microsoft.com/office/drawing/2014/main" id="{8A4415F7-4181-6795-1F39-B2B0A26CC8F2}"/>
              </a:ext>
            </a:extLst>
          </p:cNvPr>
          <p:cNvCxnSpPr>
            <a:cxnSpLocks/>
          </p:cNvCxnSpPr>
          <p:nvPr/>
        </p:nvCxnSpPr>
        <p:spPr>
          <a:xfrm flipV="1">
            <a:off x="4394240" y="1140988"/>
            <a:ext cx="5606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CuadroTexto 170">
            <a:extLst>
              <a:ext uri="{FF2B5EF4-FFF2-40B4-BE49-F238E27FC236}">
                <a16:creationId xmlns:a16="http://schemas.microsoft.com/office/drawing/2014/main" id="{95C21E4B-CC0A-62F6-0EFC-D47F85A41E8D}"/>
              </a:ext>
            </a:extLst>
          </p:cNvPr>
          <p:cNvSpPr txBox="1"/>
          <p:nvPr/>
        </p:nvSpPr>
        <p:spPr>
          <a:xfrm>
            <a:off x="4340835" y="902964"/>
            <a:ext cx="6674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KM12C</a:t>
            </a:r>
          </a:p>
        </p:txBody>
      </p:sp>
      <p:cxnSp>
        <p:nvCxnSpPr>
          <p:cNvPr id="172" name="Conector recto 171">
            <a:extLst>
              <a:ext uri="{FF2B5EF4-FFF2-40B4-BE49-F238E27FC236}">
                <a16:creationId xmlns:a16="http://schemas.microsoft.com/office/drawing/2014/main" id="{7E06E1D2-C6DC-7894-3083-8766594D4F02}"/>
              </a:ext>
            </a:extLst>
          </p:cNvPr>
          <p:cNvCxnSpPr>
            <a:cxnSpLocks/>
          </p:cNvCxnSpPr>
          <p:nvPr/>
        </p:nvCxnSpPr>
        <p:spPr>
          <a:xfrm flipV="1">
            <a:off x="5079849" y="1140988"/>
            <a:ext cx="5606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CuadroTexto 172">
            <a:extLst>
              <a:ext uri="{FF2B5EF4-FFF2-40B4-BE49-F238E27FC236}">
                <a16:creationId xmlns:a16="http://schemas.microsoft.com/office/drawing/2014/main" id="{A27AD3DC-26AC-3D15-C15E-00E314A91526}"/>
              </a:ext>
            </a:extLst>
          </p:cNvPr>
          <p:cNvSpPr txBox="1"/>
          <p:nvPr/>
        </p:nvSpPr>
        <p:spPr>
          <a:xfrm>
            <a:off x="4965484" y="902964"/>
            <a:ext cx="7840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KM12SM</a:t>
            </a:r>
          </a:p>
        </p:txBody>
      </p:sp>
      <p:pic>
        <p:nvPicPr>
          <p:cNvPr id="174" name="Imagen 173" descr="Imagen que contiene cama&#10;&#10;Descripción generada automáticamente">
            <a:extLst>
              <a:ext uri="{FF2B5EF4-FFF2-40B4-BE49-F238E27FC236}">
                <a16:creationId xmlns:a16="http://schemas.microsoft.com/office/drawing/2014/main" id="{39A0E632-D757-4952-6D9D-2DAE6E7AFE8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860" t="4164" r="61648" b="62059"/>
          <a:stretch/>
        </p:blipFill>
        <p:spPr>
          <a:xfrm>
            <a:off x="5828916" y="1832095"/>
            <a:ext cx="1433981" cy="227372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00" name="CuadroTexto 199">
            <a:extLst>
              <a:ext uri="{FF2B5EF4-FFF2-40B4-BE49-F238E27FC236}">
                <a16:creationId xmlns:a16="http://schemas.microsoft.com/office/drawing/2014/main" id="{66A95401-9388-027D-DA3B-BD34159AF2B9}"/>
              </a:ext>
            </a:extLst>
          </p:cNvPr>
          <p:cNvSpPr txBox="1"/>
          <p:nvPr/>
        </p:nvSpPr>
        <p:spPr>
          <a:xfrm rot="16200000">
            <a:off x="602235" y="1364256"/>
            <a:ext cx="742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CuadroTexto 200">
            <a:extLst>
              <a:ext uri="{FF2B5EF4-FFF2-40B4-BE49-F238E27FC236}">
                <a16:creationId xmlns:a16="http://schemas.microsoft.com/office/drawing/2014/main" id="{11A8CF74-B86E-1AF2-403D-6336E4CCA99C}"/>
              </a:ext>
            </a:extLst>
          </p:cNvPr>
          <p:cNvSpPr txBox="1"/>
          <p:nvPr/>
        </p:nvSpPr>
        <p:spPr>
          <a:xfrm rot="16200000">
            <a:off x="926769" y="1364256"/>
            <a:ext cx="742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SPRYD7</a:t>
            </a:r>
          </a:p>
        </p:txBody>
      </p:sp>
      <p:sp>
        <p:nvSpPr>
          <p:cNvPr id="202" name="CuadroTexto 201">
            <a:extLst>
              <a:ext uri="{FF2B5EF4-FFF2-40B4-BE49-F238E27FC236}">
                <a16:creationId xmlns:a16="http://schemas.microsoft.com/office/drawing/2014/main" id="{79D0D06A-8004-EDED-CA6A-D07FB58AA70B}"/>
              </a:ext>
            </a:extLst>
          </p:cNvPr>
          <p:cNvSpPr txBox="1"/>
          <p:nvPr/>
        </p:nvSpPr>
        <p:spPr>
          <a:xfrm rot="16200000">
            <a:off x="1249314" y="1364256"/>
            <a:ext cx="742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CuadroTexto 202">
            <a:extLst>
              <a:ext uri="{FF2B5EF4-FFF2-40B4-BE49-F238E27FC236}">
                <a16:creationId xmlns:a16="http://schemas.microsoft.com/office/drawing/2014/main" id="{3DC22E65-DF3A-FB38-5C48-706801D6A824}"/>
              </a:ext>
            </a:extLst>
          </p:cNvPr>
          <p:cNvSpPr txBox="1"/>
          <p:nvPr/>
        </p:nvSpPr>
        <p:spPr>
          <a:xfrm rot="16200000">
            <a:off x="1613852" y="1364256"/>
            <a:ext cx="742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SPRYD7</a:t>
            </a:r>
          </a:p>
        </p:txBody>
      </p:sp>
      <p:sp>
        <p:nvSpPr>
          <p:cNvPr id="204" name="CuadroTexto 203">
            <a:extLst>
              <a:ext uri="{FF2B5EF4-FFF2-40B4-BE49-F238E27FC236}">
                <a16:creationId xmlns:a16="http://schemas.microsoft.com/office/drawing/2014/main" id="{12D30435-7B32-1275-B659-4E004E28C022}"/>
              </a:ext>
            </a:extLst>
          </p:cNvPr>
          <p:cNvSpPr txBox="1"/>
          <p:nvPr/>
        </p:nvSpPr>
        <p:spPr>
          <a:xfrm rot="16200000">
            <a:off x="2016670" y="1364256"/>
            <a:ext cx="742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CuadroTexto 204">
            <a:extLst>
              <a:ext uri="{FF2B5EF4-FFF2-40B4-BE49-F238E27FC236}">
                <a16:creationId xmlns:a16="http://schemas.microsoft.com/office/drawing/2014/main" id="{81C23324-6E55-C7E0-7087-44EAD017165F}"/>
              </a:ext>
            </a:extLst>
          </p:cNvPr>
          <p:cNvSpPr txBox="1"/>
          <p:nvPr/>
        </p:nvSpPr>
        <p:spPr>
          <a:xfrm rot="16200000">
            <a:off x="2342259" y="1364256"/>
            <a:ext cx="742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SPRYD7</a:t>
            </a:r>
          </a:p>
        </p:txBody>
      </p:sp>
      <p:sp>
        <p:nvSpPr>
          <p:cNvPr id="206" name="CuadroTexto 205">
            <a:extLst>
              <a:ext uri="{FF2B5EF4-FFF2-40B4-BE49-F238E27FC236}">
                <a16:creationId xmlns:a16="http://schemas.microsoft.com/office/drawing/2014/main" id="{ABCACA96-0209-B3D6-ECC3-A5112D5E7665}"/>
              </a:ext>
            </a:extLst>
          </p:cNvPr>
          <p:cNvSpPr txBox="1"/>
          <p:nvPr/>
        </p:nvSpPr>
        <p:spPr>
          <a:xfrm rot="16200000">
            <a:off x="2652105" y="1364256"/>
            <a:ext cx="742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CuadroTexto 206">
            <a:extLst>
              <a:ext uri="{FF2B5EF4-FFF2-40B4-BE49-F238E27FC236}">
                <a16:creationId xmlns:a16="http://schemas.microsoft.com/office/drawing/2014/main" id="{2C1960F0-A3B1-30A8-16D0-1C91446102A6}"/>
              </a:ext>
            </a:extLst>
          </p:cNvPr>
          <p:cNvSpPr txBox="1"/>
          <p:nvPr/>
        </p:nvSpPr>
        <p:spPr>
          <a:xfrm rot="16200000">
            <a:off x="2980870" y="1364256"/>
            <a:ext cx="742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SPRYD7</a:t>
            </a:r>
          </a:p>
        </p:txBody>
      </p:sp>
      <p:sp>
        <p:nvSpPr>
          <p:cNvPr id="208" name="CuadroTexto 207">
            <a:extLst>
              <a:ext uri="{FF2B5EF4-FFF2-40B4-BE49-F238E27FC236}">
                <a16:creationId xmlns:a16="http://schemas.microsoft.com/office/drawing/2014/main" id="{3F7C3D23-5F55-F23A-E2F2-FE98F6E6A4D4}"/>
              </a:ext>
            </a:extLst>
          </p:cNvPr>
          <p:cNvSpPr txBox="1"/>
          <p:nvPr/>
        </p:nvSpPr>
        <p:spPr>
          <a:xfrm>
            <a:off x="319315" y="2995476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209" name="CuadroTexto 208">
            <a:extLst>
              <a:ext uri="{FF2B5EF4-FFF2-40B4-BE49-F238E27FC236}">
                <a16:creationId xmlns:a16="http://schemas.microsoft.com/office/drawing/2014/main" id="{940DB99E-F468-A5D1-17F3-D1693B00F310}"/>
              </a:ext>
            </a:extLst>
          </p:cNvPr>
          <p:cNvSpPr txBox="1"/>
          <p:nvPr/>
        </p:nvSpPr>
        <p:spPr>
          <a:xfrm>
            <a:off x="319315" y="3802976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210" name="CuadroTexto 209">
            <a:extLst>
              <a:ext uri="{FF2B5EF4-FFF2-40B4-BE49-F238E27FC236}">
                <a16:creationId xmlns:a16="http://schemas.microsoft.com/office/drawing/2014/main" id="{2F42307A-AA6C-3D7D-1AC4-0DF0DC3136A7}"/>
              </a:ext>
            </a:extLst>
          </p:cNvPr>
          <p:cNvSpPr txBox="1"/>
          <p:nvPr/>
        </p:nvSpPr>
        <p:spPr>
          <a:xfrm>
            <a:off x="319315" y="2592020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211" name="CuadroTexto 210">
            <a:extLst>
              <a:ext uri="{FF2B5EF4-FFF2-40B4-BE49-F238E27FC236}">
                <a16:creationId xmlns:a16="http://schemas.microsoft.com/office/drawing/2014/main" id="{5712C23B-32B2-150E-6A88-5EEE8514ACD9}"/>
              </a:ext>
            </a:extLst>
          </p:cNvPr>
          <p:cNvSpPr txBox="1"/>
          <p:nvPr/>
        </p:nvSpPr>
        <p:spPr>
          <a:xfrm>
            <a:off x="319315" y="2385234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212" name="CuadroTexto 211">
            <a:extLst>
              <a:ext uri="{FF2B5EF4-FFF2-40B4-BE49-F238E27FC236}">
                <a16:creationId xmlns:a16="http://schemas.microsoft.com/office/drawing/2014/main" id="{539B8492-6C84-1F4A-46A6-A80029B01AF8}"/>
              </a:ext>
            </a:extLst>
          </p:cNvPr>
          <p:cNvSpPr txBox="1"/>
          <p:nvPr/>
        </p:nvSpPr>
        <p:spPr>
          <a:xfrm>
            <a:off x="319315" y="2222504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13" name="CuadroTexto 212">
            <a:extLst>
              <a:ext uri="{FF2B5EF4-FFF2-40B4-BE49-F238E27FC236}">
                <a16:creationId xmlns:a16="http://schemas.microsoft.com/office/drawing/2014/main" id="{7C89EB2F-3584-4F39-8C83-42D4AEB02E27}"/>
              </a:ext>
            </a:extLst>
          </p:cNvPr>
          <p:cNvSpPr txBox="1"/>
          <p:nvPr/>
        </p:nvSpPr>
        <p:spPr>
          <a:xfrm>
            <a:off x="319315" y="2095111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214" name="CuadroTexto 213">
            <a:extLst>
              <a:ext uri="{FF2B5EF4-FFF2-40B4-BE49-F238E27FC236}">
                <a16:creationId xmlns:a16="http://schemas.microsoft.com/office/drawing/2014/main" id="{DC07AE5F-9788-83A6-58B7-02B09A035B32}"/>
              </a:ext>
            </a:extLst>
          </p:cNvPr>
          <p:cNvSpPr txBox="1"/>
          <p:nvPr/>
        </p:nvSpPr>
        <p:spPr>
          <a:xfrm>
            <a:off x="319315" y="1943445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215" name="CuadroTexto 214">
            <a:extLst>
              <a:ext uri="{FF2B5EF4-FFF2-40B4-BE49-F238E27FC236}">
                <a16:creationId xmlns:a16="http://schemas.microsoft.com/office/drawing/2014/main" id="{E71BF8FD-60B2-A983-5E59-0929D9EC3166}"/>
              </a:ext>
            </a:extLst>
          </p:cNvPr>
          <p:cNvSpPr txBox="1"/>
          <p:nvPr/>
        </p:nvSpPr>
        <p:spPr>
          <a:xfrm>
            <a:off x="319315" y="1597153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6" name="Conector recto 215">
            <a:extLst>
              <a:ext uri="{FF2B5EF4-FFF2-40B4-BE49-F238E27FC236}">
                <a16:creationId xmlns:a16="http://schemas.microsoft.com/office/drawing/2014/main" id="{9234FBAB-04DE-DF30-91DA-A065E9F7BFDE}"/>
              </a:ext>
            </a:extLst>
          </p:cNvPr>
          <p:cNvCxnSpPr>
            <a:cxnSpLocks/>
          </p:cNvCxnSpPr>
          <p:nvPr/>
        </p:nvCxnSpPr>
        <p:spPr>
          <a:xfrm flipV="1">
            <a:off x="2217394" y="1145348"/>
            <a:ext cx="5606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7" name="CuadroTexto 216">
            <a:extLst>
              <a:ext uri="{FF2B5EF4-FFF2-40B4-BE49-F238E27FC236}">
                <a16:creationId xmlns:a16="http://schemas.microsoft.com/office/drawing/2014/main" id="{E5AC7F98-64AF-6AA3-BC2B-678421DC3D92}"/>
              </a:ext>
            </a:extLst>
          </p:cNvPr>
          <p:cNvSpPr txBox="1"/>
          <p:nvPr/>
        </p:nvSpPr>
        <p:spPr>
          <a:xfrm>
            <a:off x="2163989" y="907324"/>
            <a:ext cx="6674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SW480</a:t>
            </a:r>
          </a:p>
        </p:txBody>
      </p:sp>
      <p:sp>
        <p:nvSpPr>
          <p:cNvPr id="218" name="CuadroTexto 217">
            <a:extLst>
              <a:ext uri="{FF2B5EF4-FFF2-40B4-BE49-F238E27FC236}">
                <a16:creationId xmlns:a16="http://schemas.microsoft.com/office/drawing/2014/main" id="{D136DCE6-A43A-F6B3-331F-4F3D40DB4F1B}"/>
              </a:ext>
            </a:extLst>
          </p:cNvPr>
          <p:cNvSpPr txBox="1"/>
          <p:nvPr/>
        </p:nvSpPr>
        <p:spPr>
          <a:xfrm>
            <a:off x="319315" y="3221202"/>
            <a:ext cx="490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219" name="Conector recto 218">
            <a:extLst>
              <a:ext uri="{FF2B5EF4-FFF2-40B4-BE49-F238E27FC236}">
                <a16:creationId xmlns:a16="http://schemas.microsoft.com/office/drawing/2014/main" id="{750807A7-9CE7-E849-DE32-586DB60E6979}"/>
              </a:ext>
            </a:extLst>
          </p:cNvPr>
          <p:cNvCxnSpPr>
            <a:cxnSpLocks/>
          </p:cNvCxnSpPr>
          <p:nvPr/>
        </p:nvCxnSpPr>
        <p:spPr>
          <a:xfrm flipV="1">
            <a:off x="2903003" y="1145348"/>
            <a:ext cx="5606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0" name="CuadroTexto 219">
            <a:extLst>
              <a:ext uri="{FF2B5EF4-FFF2-40B4-BE49-F238E27FC236}">
                <a16:creationId xmlns:a16="http://schemas.microsoft.com/office/drawing/2014/main" id="{73A03FF5-AB76-F717-4F78-EF60C9224227}"/>
              </a:ext>
            </a:extLst>
          </p:cNvPr>
          <p:cNvSpPr txBox="1"/>
          <p:nvPr/>
        </p:nvSpPr>
        <p:spPr>
          <a:xfrm>
            <a:off x="2849598" y="907324"/>
            <a:ext cx="6674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SW620</a:t>
            </a:r>
          </a:p>
        </p:txBody>
      </p:sp>
      <p:cxnSp>
        <p:nvCxnSpPr>
          <p:cNvPr id="221" name="Conector recto 220">
            <a:extLst>
              <a:ext uri="{FF2B5EF4-FFF2-40B4-BE49-F238E27FC236}">
                <a16:creationId xmlns:a16="http://schemas.microsoft.com/office/drawing/2014/main" id="{51521DBF-EF16-5163-F52E-710D875C9E2E}"/>
              </a:ext>
            </a:extLst>
          </p:cNvPr>
          <p:cNvCxnSpPr>
            <a:cxnSpLocks/>
          </p:cNvCxnSpPr>
          <p:nvPr/>
        </p:nvCxnSpPr>
        <p:spPr>
          <a:xfrm flipV="1">
            <a:off x="841322" y="1140255"/>
            <a:ext cx="5606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2" name="CuadroTexto 221">
            <a:extLst>
              <a:ext uri="{FF2B5EF4-FFF2-40B4-BE49-F238E27FC236}">
                <a16:creationId xmlns:a16="http://schemas.microsoft.com/office/drawing/2014/main" id="{43BD3D47-CAA7-6752-88A6-5BD5FD041A3C}"/>
              </a:ext>
            </a:extLst>
          </p:cNvPr>
          <p:cNvSpPr txBox="1"/>
          <p:nvPr/>
        </p:nvSpPr>
        <p:spPr>
          <a:xfrm>
            <a:off x="787917" y="902231"/>
            <a:ext cx="6674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KM12C</a:t>
            </a:r>
          </a:p>
        </p:txBody>
      </p:sp>
      <p:cxnSp>
        <p:nvCxnSpPr>
          <p:cNvPr id="223" name="Conector recto 222">
            <a:extLst>
              <a:ext uri="{FF2B5EF4-FFF2-40B4-BE49-F238E27FC236}">
                <a16:creationId xmlns:a16="http://schemas.microsoft.com/office/drawing/2014/main" id="{8DE5A3FF-3781-64B2-D3A7-5E982639B63B}"/>
              </a:ext>
            </a:extLst>
          </p:cNvPr>
          <p:cNvCxnSpPr>
            <a:cxnSpLocks/>
          </p:cNvCxnSpPr>
          <p:nvPr/>
        </p:nvCxnSpPr>
        <p:spPr>
          <a:xfrm flipV="1">
            <a:off x="1526931" y="1140255"/>
            <a:ext cx="5606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4" name="CuadroTexto 223">
            <a:extLst>
              <a:ext uri="{FF2B5EF4-FFF2-40B4-BE49-F238E27FC236}">
                <a16:creationId xmlns:a16="http://schemas.microsoft.com/office/drawing/2014/main" id="{24A851FA-19BD-A662-9458-F588C53AFF76}"/>
              </a:ext>
            </a:extLst>
          </p:cNvPr>
          <p:cNvSpPr txBox="1"/>
          <p:nvPr/>
        </p:nvSpPr>
        <p:spPr>
          <a:xfrm>
            <a:off x="1412566" y="902231"/>
            <a:ext cx="7840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KM12SM</a:t>
            </a:r>
          </a:p>
        </p:txBody>
      </p:sp>
      <p:pic>
        <p:nvPicPr>
          <p:cNvPr id="225" name="Imagen 224" descr="Imagen que contiene artículos, refrigerador, morado, tabla&#10;&#10;Descripción generada automáticamente">
            <a:extLst>
              <a:ext uri="{FF2B5EF4-FFF2-40B4-BE49-F238E27FC236}">
                <a16:creationId xmlns:a16="http://schemas.microsoft.com/office/drawing/2014/main" id="{3396CE35-9CC1-2670-6027-6434C30CE0C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2000" contrast="1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566" t="10308" r="50798" b="73749"/>
          <a:stretch/>
        </p:blipFill>
        <p:spPr>
          <a:xfrm rot="5400000">
            <a:off x="1781368" y="2310236"/>
            <a:ext cx="2271035" cy="132284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26" name="CuadroTexto 225">
            <a:extLst>
              <a:ext uri="{FF2B5EF4-FFF2-40B4-BE49-F238E27FC236}">
                <a16:creationId xmlns:a16="http://schemas.microsoft.com/office/drawing/2014/main" id="{F0DB339F-9E40-B621-B221-BB7312CF23A9}"/>
              </a:ext>
            </a:extLst>
          </p:cNvPr>
          <p:cNvSpPr txBox="1"/>
          <p:nvPr/>
        </p:nvSpPr>
        <p:spPr>
          <a:xfrm>
            <a:off x="232179" y="810993"/>
            <a:ext cx="357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7" name="CuadroTexto 226">
            <a:extLst>
              <a:ext uri="{FF2B5EF4-FFF2-40B4-BE49-F238E27FC236}">
                <a16:creationId xmlns:a16="http://schemas.microsoft.com/office/drawing/2014/main" id="{D39B3F3C-70D5-79C8-CBFD-1F765ABBF45B}"/>
              </a:ext>
            </a:extLst>
          </p:cNvPr>
          <p:cNvSpPr txBox="1"/>
          <p:nvPr/>
        </p:nvSpPr>
        <p:spPr>
          <a:xfrm>
            <a:off x="3843619" y="810993"/>
            <a:ext cx="357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0CB283F4-E426-091B-9FD5-3CA17FE72C3A}"/>
              </a:ext>
            </a:extLst>
          </p:cNvPr>
          <p:cNvSpPr txBox="1"/>
          <p:nvPr/>
        </p:nvSpPr>
        <p:spPr>
          <a:xfrm>
            <a:off x="414867" y="5703657"/>
            <a:ext cx="684803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 1. </a:t>
            </a:r>
            <a:r>
              <a:rPr lang="en-US" sz="1050" dirty="0">
                <a:latin typeface="Palatino Linotype" panose="02040502050505030304" pitchFamily="18" charset="0"/>
                <a:cs typeface="Arial" panose="020B0604020202020204" pitchFamily="34" charset="0"/>
              </a:rPr>
              <a:t>Quality control of the cell protein extracts used for proteomics and western blot analyses. Coomassie blue staining (</a:t>
            </a:r>
            <a:r>
              <a:rPr lang="en-US" sz="105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en-US" sz="1050" dirty="0">
                <a:latin typeface="Palatino Linotype" panose="02040502050505030304" pitchFamily="18" charset="0"/>
                <a:cs typeface="Arial" panose="020B0604020202020204" pitchFamily="34" charset="0"/>
              </a:rPr>
              <a:t>) after PAGE-SDS and Ponceau red staining (</a:t>
            </a:r>
            <a:r>
              <a:rPr lang="en-US" sz="105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sz="1050" dirty="0">
                <a:latin typeface="Palatino Linotype" panose="02040502050505030304" pitchFamily="18" charset="0"/>
                <a:cs typeface="Arial" panose="020B0604020202020204" pitchFamily="34" charset="0"/>
              </a:rPr>
              <a:t>) after transference to nitrocellulose membranes confirmed the high quality and the concentration of the cell protein extracts used for TMT analysis and western blot, respectively.</a:t>
            </a:r>
            <a:endParaRPr lang="en-US" sz="105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832191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1</TotalTime>
  <Words>108</Words>
  <Application>Microsoft Office PowerPoint</Application>
  <PresentationFormat>Personalizado</PresentationFormat>
  <Paragraphs>4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odrigo BM</dc:creator>
  <cp:lastModifiedBy>ANA MONTERO CALLE</cp:lastModifiedBy>
  <cp:revision>6</cp:revision>
  <dcterms:created xsi:type="dcterms:W3CDTF">2023-03-24T13:43:32Z</dcterms:created>
  <dcterms:modified xsi:type="dcterms:W3CDTF">2023-06-11T16:38:45Z</dcterms:modified>
</cp:coreProperties>
</file>